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9" r:id="rId3"/>
    <p:sldId id="262" r:id="rId4"/>
    <p:sldId id="264" r:id="rId5"/>
    <p:sldId id="265" r:id="rId6"/>
    <p:sldId id="266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99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3757EB-C7E7-CFE9-2C53-8C2A82AFD2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7BB82C-813A-810E-291B-1C6E5A741B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D23D74-3FA8-373B-0864-8F83715D9B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70D82-3F7A-4203-9C2C-A67C95FC0EB6}" type="datetimeFigureOut">
              <a:rPr lang="en-US" smtClean="0"/>
              <a:t>10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A8076B-1B20-2318-3A13-280838994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416FDD-2F03-C725-DFB4-39136258F3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E0BB5-B71B-432A-9CF3-6706538C5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327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3C8373-58CC-3B3B-3B6A-C99BEA43E2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E9F722-802D-8909-346B-69E992095C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978ED4-0579-5086-AFC9-4AD25D24C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70D82-3F7A-4203-9C2C-A67C95FC0EB6}" type="datetimeFigureOut">
              <a:rPr lang="en-US" smtClean="0"/>
              <a:t>10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600F40-DFD8-AADD-0B5B-6976591C63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3B4ABE-BAB6-6434-7AAC-A9925D2E3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E0BB5-B71B-432A-9CF3-6706538C5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150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943432-4D11-7F75-B87A-56DD32D383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08544E-14B0-0B1E-5C18-991037A357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695E8C-07FD-0969-65EE-808D96826E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70D82-3F7A-4203-9C2C-A67C95FC0EB6}" type="datetimeFigureOut">
              <a:rPr lang="en-US" smtClean="0"/>
              <a:t>10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461002-8706-AE1B-DFD9-A687F716F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839F7-3199-3218-DC9D-D2F3AF222E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E0BB5-B71B-432A-9CF3-6706538C5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487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B4C756-A443-59B5-7036-D91F2B7AC8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795CBB-A352-C850-9948-6C9CF8D74B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279FF4-EF71-E46A-E391-BB46979CC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70D82-3F7A-4203-9C2C-A67C95FC0EB6}" type="datetimeFigureOut">
              <a:rPr lang="en-US" smtClean="0"/>
              <a:t>10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6DD7C7-5349-55D1-FF2B-C2E0897D2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B3C6F1-EA4B-B522-78DE-AA1B95D2B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E0BB5-B71B-432A-9CF3-6706538C5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5503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90A008-20BE-19C8-974C-E54618114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7B90B9-CC56-27E8-8EC8-209C382126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9A5446-B030-F4AA-FABF-549D94F8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70D82-3F7A-4203-9C2C-A67C95FC0EB6}" type="datetimeFigureOut">
              <a:rPr lang="en-US" smtClean="0"/>
              <a:t>10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D9D58A-E61A-054C-CEEB-83441A711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054F4A-9AF5-7990-1229-D358E641CF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E0BB5-B71B-432A-9CF3-6706538C5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432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9E4CB5-0A4B-ADAE-258D-ED6738EEEB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EDE114-8FE4-676F-E9D6-BC959185DD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211654-1717-8246-586E-258DE021B6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08AA1E-6D5A-9C3C-35FB-E3A1C85D5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70D82-3F7A-4203-9C2C-A67C95FC0EB6}" type="datetimeFigureOut">
              <a:rPr lang="en-US" smtClean="0"/>
              <a:t>10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F57D50-D2F4-B73F-E3B8-1D9C96641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5745AA-66A1-3F7B-B57D-26BC3A8BB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E0BB5-B71B-432A-9CF3-6706538C5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274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D6FED2-E5E6-75FB-75CD-94C14B156E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29992F-4A9F-5570-6728-055E1DF702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35DBDF-FF0B-ED7B-9359-E57C1A6D5D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82EDD14-E2B2-1FBE-33D0-473837A5BF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5D0173C-2D8D-BA5E-E97A-788C2C3555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93F9698-E1CD-C53E-E690-596C9B57A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70D82-3F7A-4203-9C2C-A67C95FC0EB6}" type="datetimeFigureOut">
              <a:rPr lang="en-US" smtClean="0"/>
              <a:t>10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199D89E-CAFF-FBF0-B083-2F4E6DD89D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E8426B-1B7A-8B02-0C63-89599C4CB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E0BB5-B71B-432A-9CF3-6706538C5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627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4F8DFB-F111-F231-0AE7-103163BAE5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658E898-8EEF-42E3-5FAB-B07B9417F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70D82-3F7A-4203-9C2C-A67C95FC0EB6}" type="datetimeFigureOut">
              <a:rPr lang="en-US" smtClean="0"/>
              <a:t>10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D245A04-5443-D385-493A-C2B0A9F36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3944143-D730-602B-8F80-FC05284ABD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E0BB5-B71B-432A-9CF3-6706538C5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99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A93493-C7EA-3CB1-34F5-82F054B90A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70D82-3F7A-4203-9C2C-A67C95FC0EB6}" type="datetimeFigureOut">
              <a:rPr lang="en-US" smtClean="0"/>
              <a:t>10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C8FB63A-8F77-67E7-F7AA-60E289CD7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E504AD1-8F5B-5601-453D-6F0CAF2FA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E0BB5-B71B-432A-9CF3-6706538C5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597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0DA45D-C40A-EBB2-D99B-57370FC0D2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5AA024-4A69-8046-4D9E-EE01C2D2E4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FAB268-3DF2-4506-7743-958B53B763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626E36-4784-8F85-7321-8DBB4DCD4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70D82-3F7A-4203-9C2C-A67C95FC0EB6}" type="datetimeFigureOut">
              <a:rPr lang="en-US" smtClean="0"/>
              <a:t>10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EDF88D-EB6D-1ECE-0BBA-F5600F6BD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2D2E31-4234-176F-CFA5-07ECD57EF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E0BB5-B71B-432A-9CF3-6706538C5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130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F55A9A-CA1B-E61B-C210-E3B6B2BA1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C8A68F-FB5B-0849-EEE3-61E1F67479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5A4E25-5DDA-845D-867B-F38EB537E5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43DFFF-D9B4-FDE2-EB30-B688F0CE9F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70D82-3F7A-4203-9C2C-A67C95FC0EB6}" type="datetimeFigureOut">
              <a:rPr lang="en-US" smtClean="0"/>
              <a:t>10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3EC427-0E6F-8B51-8BAC-4CEB05196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81C2D7-7E13-C6A5-78EC-B6FD78A8B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E0BB5-B71B-432A-9CF3-6706538C5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089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3928E5-B5BB-A7A2-58BA-026AA14B1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11A585-73D2-1E80-40FC-54D9B43C47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51ABE8-6816-F132-70AA-97A9893EAD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270D82-3F7A-4203-9C2C-A67C95FC0EB6}" type="datetimeFigureOut">
              <a:rPr lang="en-US" smtClean="0"/>
              <a:t>10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D5245D-457A-8A81-44F9-534B684798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442BE6-3E0E-07E3-D42C-60440A7BD2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8E0BB5-B71B-432A-9CF3-6706538C57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241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6D5E9370-2CAE-F5E8-C0B5-B1BCC940F5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433119" y="4491271"/>
            <a:ext cx="9144000" cy="1655762"/>
          </a:xfrm>
        </p:spPr>
        <p:txBody>
          <a:bodyPr/>
          <a:lstStyle/>
          <a:p>
            <a:r>
              <a:rPr lang="en-US" dirty="0"/>
              <a:t>Supplementary Figures</a:t>
            </a:r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4290661C-0537-1715-F6B1-19D9F4DDBF32}"/>
              </a:ext>
            </a:extLst>
          </p:cNvPr>
          <p:cNvSpPr txBox="1">
            <a:spLocks/>
          </p:cNvSpPr>
          <p:nvPr/>
        </p:nvSpPr>
        <p:spPr>
          <a:xfrm>
            <a:off x="1524000" y="1041400"/>
            <a:ext cx="9144000" cy="2387600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4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bsolute quantitation of human wild-type DNAI1 protein in lung tissue using a </a:t>
            </a:r>
            <a:r>
              <a:rPr lang="en-US" sz="2400" b="1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nanoLC</a:t>
            </a:r>
            <a:r>
              <a:rPr lang="en-US" sz="24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-PRM-MS-based targeted proteomics approach coupled with immunoprecipitation </a:t>
            </a:r>
            <a:br>
              <a:rPr lang="en-US" sz="2400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  <a:br>
              <a:rPr lang="en-US" sz="2400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en-US" sz="18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ui Wang*, Xiaoyan Ni, Nicholas Clark, Kristen Randall, Lianne Boeglin, Sudha Chivukula, Caroline Woo, Frank DeRosa, Gang Sun*</a:t>
            </a:r>
            <a:r>
              <a:rPr lang="en-US" sz="1800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  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5070852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DFB62D-E8DE-1EA1-F4E0-57ED93BEFA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612776"/>
            <a:ext cx="10515600" cy="775778"/>
          </a:xfrm>
        </p:spPr>
        <p:txBody>
          <a:bodyPr>
            <a:normAutofit/>
          </a:bodyPr>
          <a:lstStyle/>
          <a:p>
            <a:r>
              <a:rPr lang="en-US" sz="2800" b="1" dirty="0"/>
              <a:t>Supplemental Figure Legen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F4EB43-6F9C-4B52-6D6C-56039A240A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699790"/>
            <a:ext cx="9639650" cy="3073546"/>
          </a:xfrm>
        </p:spPr>
        <p:txBody>
          <a:bodyPr>
            <a:normAutofit fontScale="85000" lnSpcReduction="20000"/>
          </a:bodyPr>
          <a:lstStyle/>
          <a:p>
            <a:pPr marL="0" indent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. S1 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eptide mapping for recombinant human DNAI1 protein with trypsin digestion.</a:t>
            </a:r>
            <a:r>
              <a:rPr lang="en-US" sz="18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endParaRPr lang="en-US" sz="18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0" indent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. S2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P-MS analysis for human DNAI1 spiking in mouse lung matrix and mouse lung matrix only. 1, hDNAI1 peptide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HIFDLAINK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2, hDNAI1 peptide </a:t>
            </a:r>
            <a:r>
              <a:rPr lang="en-US" sz="18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HSDPVWQVK.  </a:t>
            </a:r>
          </a:p>
          <a:p>
            <a:pPr marL="0" indent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. S3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Venn diagrams of protein ID numbers after IP-MS using Pierce IP, TER-1, Buffer A lysis buffer as IP loading buffer. </a:t>
            </a:r>
          </a:p>
          <a:p>
            <a:pPr marL="0" indent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. S4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LOD (A) and LLOQ (B) of IP-MS assay for human DNAI1 in mouse lung matrix. 1, endogenous peptide AHIFDLAINK; 2, isotope labeled peptide AHIFDLAINK^.  </a:t>
            </a:r>
            <a:endParaRPr lang="en-US" sz="18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0" indent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buNone/>
            </a:pPr>
            <a:endParaRPr lang="en-US" sz="18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0" indent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buNone/>
            </a:pPr>
            <a:endParaRPr lang="en-US" sz="18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79566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8DC3EA-A9E9-F8D0-569F-810ED25590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. S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998AE84-A0FC-5D11-2079-DA852F4884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00837" y="485775"/>
            <a:ext cx="4146087" cy="61680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41217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1CE2B9-7783-3E0D-0D0C-EC084FA5F0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. S2</a:t>
            </a:r>
            <a:br>
              <a:rPr lang="en-US" dirty="0"/>
            </a:b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A7F00DE-365A-F529-8B4F-0054F7C7EE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62668" y="448252"/>
            <a:ext cx="2600325" cy="313372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A29A625-9186-A88E-4247-B137EF0055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45991" y="365125"/>
            <a:ext cx="2600325" cy="313372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7C71F85-4723-2621-0B23-F0F2C39C04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62668" y="3258700"/>
            <a:ext cx="2600325" cy="313372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54B9614-E9C4-F385-3F33-81634E44CDD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51315" y="3224990"/>
            <a:ext cx="2600325" cy="313372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D566E3C-0567-1DA4-0F40-D0ADC83799E0}"/>
              </a:ext>
            </a:extLst>
          </p:cNvPr>
          <p:cNvSpPr txBox="1"/>
          <p:nvPr/>
        </p:nvSpPr>
        <p:spPr>
          <a:xfrm>
            <a:off x="6430971" y="603901"/>
            <a:ext cx="511679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-1</a:t>
            </a:r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A-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C868BB7-ED4B-6857-678C-AEA32933BDD2}"/>
              </a:ext>
            </a:extLst>
          </p:cNvPr>
          <p:cNvSpPr txBox="1"/>
          <p:nvPr/>
        </p:nvSpPr>
        <p:spPr>
          <a:xfrm>
            <a:off x="9486452" y="582155"/>
            <a:ext cx="511679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-1</a:t>
            </a:r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B-2</a:t>
            </a:r>
          </a:p>
        </p:txBody>
      </p:sp>
    </p:spTree>
    <p:extLst>
      <p:ext uri="{BB962C8B-B14F-4D97-AF65-F5344CB8AC3E}">
        <p14:creationId xmlns:p14="http://schemas.microsoft.com/office/powerpoint/2010/main" val="29091992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24DFF3-55A4-0850-CFF6-B2332C46DC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. S3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E08B956-C4E2-43D8-34BA-FD6D0BDF0C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370" y="2085712"/>
            <a:ext cx="5943600" cy="365760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77A6FE5C-0F9D-2501-7C3F-BEC1635C2880}"/>
              </a:ext>
            </a:extLst>
          </p:cNvPr>
          <p:cNvSpPr/>
          <p:nvPr/>
        </p:nvSpPr>
        <p:spPr>
          <a:xfrm>
            <a:off x="4894407" y="2786044"/>
            <a:ext cx="1438563" cy="2947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F549246-05CC-E8CA-D6E4-6100E0F7B598}"/>
              </a:ext>
            </a:extLst>
          </p:cNvPr>
          <p:cNvSpPr txBox="1"/>
          <p:nvPr/>
        </p:nvSpPr>
        <p:spPr>
          <a:xfrm>
            <a:off x="4985613" y="2711428"/>
            <a:ext cx="990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ierce IP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9D2AAC7-C027-31EB-D3E1-7A413ED27F59}"/>
              </a:ext>
            </a:extLst>
          </p:cNvPr>
          <p:cNvSpPr/>
          <p:nvPr/>
        </p:nvSpPr>
        <p:spPr>
          <a:xfrm>
            <a:off x="1809461" y="5290731"/>
            <a:ext cx="1551709" cy="2747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6D0B5AE-1378-3EEB-94BD-05B66878D799}"/>
              </a:ext>
            </a:extLst>
          </p:cNvPr>
          <p:cNvSpPr txBox="1"/>
          <p:nvPr/>
        </p:nvSpPr>
        <p:spPr>
          <a:xfrm>
            <a:off x="2305915" y="5243456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ER-1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80D0A20-5E36-27B5-E7BA-A8A155C49B25}"/>
              </a:ext>
            </a:extLst>
          </p:cNvPr>
          <p:cNvSpPr/>
          <p:nvPr/>
        </p:nvSpPr>
        <p:spPr>
          <a:xfrm>
            <a:off x="389369" y="2786044"/>
            <a:ext cx="1420092" cy="2947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1F9B3E8-C04B-640A-3A8B-B543B7EDA75D}"/>
              </a:ext>
            </a:extLst>
          </p:cNvPr>
          <p:cNvSpPr txBox="1"/>
          <p:nvPr/>
        </p:nvSpPr>
        <p:spPr>
          <a:xfrm>
            <a:off x="863368" y="2786044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uffer A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557BF3DD-6D32-D76E-E58A-B095705594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247170"/>
              </p:ext>
            </p:extLst>
          </p:nvPr>
        </p:nvGraphicFramePr>
        <p:xfrm>
          <a:off x="6966934" y="2647263"/>
          <a:ext cx="4392334" cy="2362200"/>
        </p:xfrm>
        <a:graphic>
          <a:graphicData uri="http://schemas.openxmlformats.org/drawingml/2006/table">
            <a:tbl>
              <a:tblPr/>
              <a:tblGrid>
                <a:gridCol w="1620833">
                  <a:extLst>
                    <a:ext uri="{9D8B030D-6E8A-4147-A177-3AD203B41FA5}">
                      <a16:colId xmlns:a16="http://schemas.microsoft.com/office/drawing/2014/main" val="2408759645"/>
                    </a:ext>
                  </a:extLst>
                </a:gridCol>
                <a:gridCol w="1583715">
                  <a:extLst>
                    <a:ext uri="{9D8B030D-6E8A-4147-A177-3AD203B41FA5}">
                      <a16:colId xmlns:a16="http://schemas.microsoft.com/office/drawing/2014/main" val="2944529532"/>
                    </a:ext>
                  </a:extLst>
                </a:gridCol>
                <a:gridCol w="1187786">
                  <a:extLst>
                    <a:ext uri="{9D8B030D-6E8A-4147-A177-3AD203B41FA5}">
                      <a16:colId xmlns:a16="http://schemas.microsoft.com/office/drawing/2014/main" val="2169454246"/>
                    </a:ext>
                  </a:extLst>
                </a:gridCol>
              </a:tblGrid>
              <a:tr h="317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in ID # (Exclusive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in ID # (All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7224035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ffer A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8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725339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erce I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8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8649792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R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3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1679432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ffer A | Pierce IP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2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8811680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erce IP | TER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0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490890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ffer A | TER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0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2722669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ffer A | Pierce IP | TER-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66960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226993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600929-3E32-05E9-BA76-002B188E9E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. S4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280DC65-191A-6EFF-0DD3-C942B3DBC2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74066" y="822427"/>
            <a:ext cx="2476500" cy="30765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4C9C507-331E-C9C3-A69F-897012B73C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73843" y="3585844"/>
            <a:ext cx="2476500" cy="307657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D34AE32-7D24-4379-D16F-FB5E6616B55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23899" y="822426"/>
            <a:ext cx="2524125" cy="307657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94828A4-A2A4-A767-48CA-82339F5461C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85340" y="3585844"/>
            <a:ext cx="2524125" cy="307657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64672AF-CE18-DDAC-3D17-FFF3DB6A2D20}"/>
              </a:ext>
            </a:extLst>
          </p:cNvPr>
          <p:cNvSpPr txBox="1"/>
          <p:nvPr/>
        </p:nvSpPr>
        <p:spPr>
          <a:xfrm>
            <a:off x="6461451" y="1057733"/>
            <a:ext cx="511679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-1</a:t>
            </a:r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A-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BC703DA-6C8C-9F65-E915-00C27B5336D0}"/>
              </a:ext>
            </a:extLst>
          </p:cNvPr>
          <p:cNvSpPr txBox="1"/>
          <p:nvPr/>
        </p:nvSpPr>
        <p:spPr>
          <a:xfrm>
            <a:off x="9203488" y="1057733"/>
            <a:ext cx="511679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-1</a:t>
            </a:r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B-2</a:t>
            </a:r>
          </a:p>
        </p:txBody>
      </p:sp>
    </p:spTree>
    <p:extLst>
      <p:ext uri="{BB962C8B-B14F-4D97-AF65-F5344CB8AC3E}">
        <p14:creationId xmlns:p14="http://schemas.microsoft.com/office/powerpoint/2010/main" val="3306271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0</TotalTime>
  <Words>239</Words>
  <Application>Microsoft Office PowerPoint</Application>
  <PresentationFormat>Widescreen</PresentationFormat>
  <Paragraphs>8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Supplemental Figure Legend</vt:lpstr>
      <vt:lpstr>Fig. S1</vt:lpstr>
      <vt:lpstr>Fig. S2 </vt:lpstr>
      <vt:lpstr>Fig. S3</vt:lpstr>
      <vt:lpstr>Fig. S4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Wang, Hui /US</dc:creator>
  <cp:lastModifiedBy>Wang, Hui /US</cp:lastModifiedBy>
  <cp:revision>3</cp:revision>
  <dcterms:created xsi:type="dcterms:W3CDTF">2023-10-25T18:11:25Z</dcterms:created>
  <dcterms:modified xsi:type="dcterms:W3CDTF">2023-10-26T17:18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9088468-0951-4aef-9cc3-0a346e475ddc_Enabled">
    <vt:lpwstr>true</vt:lpwstr>
  </property>
  <property fmtid="{D5CDD505-2E9C-101B-9397-08002B2CF9AE}" pid="3" name="MSIP_Label_d9088468-0951-4aef-9cc3-0a346e475ddc_SetDate">
    <vt:lpwstr>2023-10-25T18:21:25Z</vt:lpwstr>
  </property>
  <property fmtid="{D5CDD505-2E9C-101B-9397-08002B2CF9AE}" pid="4" name="MSIP_Label_d9088468-0951-4aef-9cc3-0a346e475ddc_Method">
    <vt:lpwstr>Privileged</vt:lpwstr>
  </property>
  <property fmtid="{D5CDD505-2E9C-101B-9397-08002B2CF9AE}" pid="5" name="MSIP_Label_d9088468-0951-4aef-9cc3-0a346e475ddc_Name">
    <vt:lpwstr>Public</vt:lpwstr>
  </property>
  <property fmtid="{D5CDD505-2E9C-101B-9397-08002B2CF9AE}" pid="6" name="MSIP_Label_d9088468-0951-4aef-9cc3-0a346e475ddc_SiteId">
    <vt:lpwstr>aca3c8d6-aa71-4e1a-a10e-03572fc58c0b</vt:lpwstr>
  </property>
  <property fmtid="{D5CDD505-2E9C-101B-9397-08002B2CF9AE}" pid="7" name="MSIP_Label_d9088468-0951-4aef-9cc3-0a346e475ddc_ActionId">
    <vt:lpwstr>bcee0b4a-b12c-41be-b104-ad9b5d02f16d</vt:lpwstr>
  </property>
  <property fmtid="{D5CDD505-2E9C-101B-9397-08002B2CF9AE}" pid="8" name="MSIP_Label_d9088468-0951-4aef-9cc3-0a346e475ddc_ContentBits">
    <vt:lpwstr>0</vt:lpwstr>
  </property>
</Properties>
</file>